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2974;&#20799;&#21307;&#23398;&#31185;\11.&#29983;&#38271;&#26354;&#32447;\ultrasound%20Dr%20and%20checkdate2020.9.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39439325232522"/>
          <c:y val="8.9341125519971171E-2"/>
          <c:w val="0.86057939567705743"/>
          <c:h val="0.79055062477984583"/>
        </c:manualLayout>
      </c:layout>
      <c:lineChart>
        <c:grouping val="standard"/>
        <c:varyColors val="0"/>
        <c:ser>
          <c:idx val="1"/>
          <c:order val="0"/>
          <c:tx>
            <c:strRef>
              <c:f>Sheet1!$AI$2</c:f>
              <c:strCache>
                <c:ptCount val="1"/>
                <c:pt idx="0">
                  <c:v>Sonographer 1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L$3:$AL$25</c:f>
                <c:numCache>
                  <c:formatCode>General</c:formatCode>
                  <c:ptCount val="23"/>
                  <c:pt idx="1">
                    <c:v>8.4</c:v>
                  </c:pt>
                  <c:pt idx="2">
                    <c:v>15.1</c:v>
                  </c:pt>
                  <c:pt idx="3">
                    <c:v>19.899999999999999</c:v>
                  </c:pt>
                  <c:pt idx="4">
                    <c:v>20</c:v>
                  </c:pt>
                  <c:pt idx="5">
                    <c:v>36.5</c:v>
                  </c:pt>
                  <c:pt idx="6">
                    <c:v>27.5</c:v>
                  </c:pt>
                  <c:pt idx="7">
                    <c:v>17.399999999999999</c:v>
                  </c:pt>
                  <c:pt idx="8">
                    <c:v>29.5</c:v>
                  </c:pt>
                  <c:pt idx="9">
                    <c:v>53.1</c:v>
                  </c:pt>
                  <c:pt idx="10">
                    <c:v>80.8</c:v>
                  </c:pt>
                  <c:pt idx="11">
                    <c:v>56.8</c:v>
                  </c:pt>
                  <c:pt idx="12">
                    <c:v>99.2</c:v>
                  </c:pt>
                  <c:pt idx="13">
                    <c:v>34.200000000000003</c:v>
                  </c:pt>
                  <c:pt idx="14">
                    <c:v>151.4</c:v>
                  </c:pt>
                  <c:pt idx="15">
                    <c:v>104.3</c:v>
                  </c:pt>
                  <c:pt idx="16">
                    <c:v>143.19999999999999</c:v>
                  </c:pt>
                  <c:pt idx="17">
                    <c:v>133.9</c:v>
                  </c:pt>
                  <c:pt idx="18">
                    <c:v>207.7</c:v>
                  </c:pt>
                  <c:pt idx="19">
                    <c:v>274</c:v>
                  </c:pt>
                  <c:pt idx="20">
                    <c:v>237</c:v>
                  </c:pt>
                  <c:pt idx="21">
                    <c:v>242.2</c:v>
                  </c:pt>
                  <c:pt idx="22">
                    <c:v>110.7</c:v>
                  </c:pt>
                </c:numCache>
              </c:numRef>
            </c:plus>
            <c:minus>
              <c:numRef>
                <c:f>Sheet1!$AL$3:$AL$25</c:f>
                <c:numCache>
                  <c:formatCode>General</c:formatCode>
                  <c:ptCount val="23"/>
                  <c:pt idx="1">
                    <c:v>8.4</c:v>
                  </c:pt>
                  <c:pt idx="2">
                    <c:v>15.1</c:v>
                  </c:pt>
                  <c:pt idx="3">
                    <c:v>19.899999999999999</c:v>
                  </c:pt>
                  <c:pt idx="4">
                    <c:v>20</c:v>
                  </c:pt>
                  <c:pt idx="5">
                    <c:v>36.5</c:v>
                  </c:pt>
                  <c:pt idx="6">
                    <c:v>27.5</c:v>
                  </c:pt>
                  <c:pt idx="7">
                    <c:v>17.399999999999999</c:v>
                  </c:pt>
                  <c:pt idx="8">
                    <c:v>29.5</c:v>
                  </c:pt>
                  <c:pt idx="9">
                    <c:v>53.1</c:v>
                  </c:pt>
                  <c:pt idx="10">
                    <c:v>80.8</c:v>
                  </c:pt>
                  <c:pt idx="11">
                    <c:v>56.8</c:v>
                  </c:pt>
                  <c:pt idx="12">
                    <c:v>99.2</c:v>
                  </c:pt>
                  <c:pt idx="13">
                    <c:v>34.200000000000003</c:v>
                  </c:pt>
                  <c:pt idx="14">
                    <c:v>151.4</c:v>
                  </c:pt>
                  <c:pt idx="15">
                    <c:v>104.3</c:v>
                  </c:pt>
                  <c:pt idx="16">
                    <c:v>143.19999999999999</c:v>
                  </c:pt>
                  <c:pt idx="17">
                    <c:v>133.9</c:v>
                  </c:pt>
                  <c:pt idx="18">
                    <c:v>207.7</c:v>
                  </c:pt>
                  <c:pt idx="19">
                    <c:v>274</c:v>
                  </c:pt>
                  <c:pt idx="20">
                    <c:v>237</c:v>
                  </c:pt>
                  <c:pt idx="21">
                    <c:v>242.2</c:v>
                  </c:pt>
                  <c:pt idx="22">
                    <c:v>110.7</c:v>
                  </c:pt>
                </c:numCache>
              </c:numRef>
            </c:minus>
          </c:errBars>
          <c:cat>
            <c:numRef>
              <c:f>Sheet1!$AG$3:$AG$25</c:f>
              <c:numCache>
                <c:formatCode>General</c:formatCode>
                <c:ptCount val="23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</c:numCache>
            </c:numRef>
          </c:cat>
          <c:val>
            <c:numRef>
              <c:f>Sheet1!$AI$3:$AI$25</c:f>
              <c:numCache>
                <c:formatCode>General</c:formatCode>
                <c:ptCount val="23"/>
                <c:pt idx="1">
                  <c:v>124.6</c:v>
                </c:pt>
                <c:pt idx="2">
                  <c:v>149.4</c:v>
                </c:pt>
                <c:pt idx="3">
                  <c:v>219.7</c:v>
                </c:pt>
                <c:pt idx="4">
                  <c:v>245.5</c:v>
                </c:pt>
                <c:pt idx="5">
                  <c:v>312.5</c:v>
                </c:pt>
                <c:pt idx="6">
                  <c:v>350.4</c:v>
                </c:pt>
                <c:pt idx="7">
                  <c:v>445.5</c:v>
                </c:pt>
                <c:pt idx="8">
                  <c:v>493.5</c:v>
                </c:pt>
                <c:pt idx="9">
                  <c:v>592.29999999999995</c:v>
                </c:pt>
                <c:pt idx="10">
                  <c:v>688.3</c:v>
                </c:pt>
                <c:pt idx="11">
                  <c:v>748.5</c:v>
                </c:pt>
                <c:pt idx="12">
                  <c:v>936.7</c:v>
                </c:pt>
                <c:pt idx="13">
                  <c:v>960.9</c:v>
                </c:pt>
                <c:pt idx="14">
                  <c:v>1170.7</c:v>
                </c:pt>
                <c:pt idx="15">
                  <c:v>1306.0999999999999</c:v>
                </c:pt>
                <c:pt idx="16">
                  <c:v>1488.9</c:v>
                </c:pt>
                <c:pt idx="17">
                  <c:v>1732.7</c:v>
                </c:pt>
                <c:pt idx="18">
                  <c:v>1830.6</c:v>
                </c:pt>
                <c:pt idx="19">
                  <c:v>1858.9</c:v>
                </c:pt>
                <c:pt idx="20">
                  <c:v>2098.1</c:v>
                </c:pt>
                <c:pt idx="21">
                  <c:v>2510.6</c:v>
                </c:pt>
                <c:pt idx="22">
                  <c:v>257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5BB-4C17-9D0C-B6AC843DA5F0}"/>
            </c:ext>
          </c:extLst>
        </c:ser>
        <c:ser>
          <c:idx val="2"/>
          <c:order val="1"/>
          <c:tx>
            <c:strRef>
              <c:f>Sheet1!$AJ$2</c:f>
              <c:strCache>
                <c:ptCount val="1"/>
                <c:pt idx="0">
                  <c:v>Sonographer 2</c:v>
                </c:pt>
              </c:strCache>
            </c:strRef>
          </c:tx>
          <c:spPr>
            <a:ln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M$3:$AM$25</c:f>
                <c:numCache>
                  <c:formatCode>General</c:formatCode>
                  <c:ptCount val="23"/>
                  <c:pt idx="0">
                    <c:v>12.7</c:v>
                  </c:pt>
                  <c:pt idx="1">
                    <c:v>12</c:v>
                  </c:pt>
                  <c:pt idx="2">
                    <c:v>17.2</c:v>
                  </c:pt>
                  <c:pt idx="3">
                    <c:v>26.5</c:v>
                  </c:pt>
                  <c:pt idx="4">
                    <c:v>31.5</c:v>
                  </c:pt>
                  <c:pt idx="5">
                    <c:v>24.5</c:v>
                  </c:pt>
                  <c:pt idx="6">
                    <c:v>42</c:v>
                  </c:pt>
                  <c:pt idx="7">
                    <c:v>32.5</c:v>
                  </c:pt>
                  <c:pt idx="8">
                    <c:v>63.8</c:v>
                  </c:pt>
                  <c:pt idx="9">
                    <c:v>58.2</c:v>
                  </c:pt>
                  <c:pt idx="10">
                    <c:v>84</c:v>
                  </c:pt>
                  <c:pt idx="11">
                    <c:v>132.80000000000001</c:v>
                  </c:pt>
                  <c:pt idx="12">
                    <c:v>99</c:v>
                  </c:pt>
                  <c:pt idx="13">
                    <c:v>111.1</c:v>
                  </c:pt>
                  <c:pt idx="14">
                    <c:v>117.4</c:v>
                  </c:pt>
                  <c:pt idx="15">
                    <c:v>130.9</c:v>
                  </c:pt>
                  <c:pt idx="16">
                    <c:v>230.5</c:v>
                  </c:pt>
                  <c:pt idx="17">
                    <c:v>124.5</c:v>
                  </c:pt>
                  <c:pt idx="18">
                    <c:v>175.4</c:v>
                  </c:pt>
                  <c:pt idx="19">
                    <c:v>302.3</c:v>
                  </c:pt>
                  <c:pt idx="20">
                    <c:v>222.6</c:v>
                  </c:pt>
                  <c:pt idx="21">
                    <c:v>279.3</c:v>
                  </c:pt>
                  <c:pt idx="22">
                    <c:v>282.8</c:v>
                  </c:pt>
                </c:numCache>
              </c:numRef>
            </c:plus>
            <c:minus>
              <c:numRef>
                <c:f>Sheet1!$AM$3:$AM$25</c:f>
                <c:numCache>
                  <c:formatCode>General</c:formatCode>
                  <c:ptCount val="23"/>
                  <c:pt idx="0">
                    <c:v>12.7</c:v>
                  </c:pt>
                  <c:pt idx="1">
                    <c:v>12</c:v>
                  </c:pt>
                  <c:pt idx="2">
                    <c:v>17.2</c:v>
                  </c:pt>
                  <c:pt idx="3">
                    <c:v>26.5</c:v>
                  </c:pt>
                  <c:pt idx="4">
                    <c:v>31.5</c:v>
                  </c:pt>
                  <c:pt idx="5">
                    <c:v>24.5</c:v>
                  </c:pt>
                  <c:pt idx="6">
                    <c:v>42</c:v>
                  </c:pt>
                  <c:pt idx="7">
                    <c:v>32.5</c:v>
                  </c:pt>
                  <c:pt idx="8">
                    <c:v>63.8</c:v>
                  </c:pt>
                  <c:pt idx="9">
                    <c:v>58.2</c:v>
                  </c:pt>
                  <c:pt idx="10">
                    <c:v>84</c:v>
                  </c:pt>
                  <c:pt idx="11">
                    <c:v>132.80000000000001</c:v>
                  </c:pt>
                  <c:pt idx="12">
                    <c:v>99</c:v>
                  </c:pt>
                  <c:pt idx="13">
                    <c:v>111.1</c:v>
                  </c:pt>
                  <c:pt idx="14">
                    <c:v>117.4</c:v>
                  </c:pt>
                  <c:pt idx="15">
                    <c:v>130.9</c:v>
                  </c:pt>
                  <c:pt idx="16">
                    <c:v>230.5</c:v>
                  </c:pt>
                  <c:pt idx="17">
                    <c:v>124.5</c:v>
                  </c:pt>
                  <c:pt idx="18">
                    <c:v>175.4</c:v>
                  </c:pt>
                  <c:pt idx="19">
                    <c:v>302.3</c:v>
                  </c:pt>
                  <c:pt idx="20">
                    <c:v>222.6</c:v>
                  </c:pt>
                  <c:pt idx="21">
                    <c:v>279.3</c:v>
                  </c:pt>
                  <c:pt idx="22">
                    <c:v>282.8</c:v>
                  </c:pt>
                </c:numCache>
              </c:numRef>
            </c:minus>
          </c:errBars>
          <c:cat>
            <c:numRef>
              <c:f>Sheet1!$AG$3:$AG$25</c:f>
              <c:numCache>
                <c:formatCode>General</c:formatCode>
                <c:ptCount val="23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</c:numCache>
            </c:numRef>
          </c:cat>
          <c:val>
            <c:numRef>
              <c:f>Sheet1!$AJ$3:$AJ$25</c:f>
              <c:numCache>
                <c:formatCode>General</c:formatCode>
                <c:ptCount val="23"/>
                <c:pt idx="0">
                  <c:v>114.8</c:v>
                </c:pt>
                <c:pt idx="1">
                  <c:v>134.30000000000001</c:v>
                </c:pt>
                <c:pt idx="2">
                  <c:v>164.8</c:v>
                </c:pt>
                <c:pt idx="3">
                  <c:v>208.2</c:v>
                </c:pt>
                <c:pt idx="4">
                  <c:v>243.6</c:v>
                </c:pt>
                <c:pt idx="5">
                  <c:v>297.5</c:v>
                </c:pt>
                <c:pt idx="6">
                  <c:v>370.8</c:v>
                </c:pt>
                <c:pt idx="7">
                  <c:v>406.2</c:v>
                </c:pt>
                <c:pt idx="8">
                  <c:v>515.79999999999995</c:v>
                </c:pt>
                <c:pt idx="9">
                  <c:v>564.20000000000005</c:v>
                </c:pt>
                <c:pt idx="10">
                  <c:v>682</c:v>
                </c:pt>
                <c:pt idx="11">
                  <c:v>816.9</c:v>
                </c:pt>
                <c:pt idx="12">
                  <c:v>887.4</c:v>
                </c:pt>
                <c:pt idx="13">
                  <c:v>1018.3</c:v>
                </c:pt>
                <c:pt idx="14">
                  <c:v>1186.5</c:v>
                </c:pt>
                <c:pt idx="15">
                  <c:v>1285.4000000000001</c:v>
                </c:pt>
                <c:pt idx="16">
                  <c:v>1511</c:v>
                </c:pt>
                <c:pt idx="17">
                  <c:v>1634.7</c:v>
                </c:pt>
                <c:pt idx="18">
                  <c:v>1858.8</c:v>
                </c:pt>
                <c:pt idx="19">
                  <c:v>1987.8</c:v>
                </c:pt>
                <c:pt idx="20">
                  <c:v>2101.3000000000002</c:v>
                </c:pt>
                <c:pt idx="21">
                  <c:v>2447.1999999999998</c:v>
                </c:pt>
                <c:pt idx="22">
                  <c:v>2402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5BB-4C17-9D0C-B6AC843DA5F0}"/>
            </c:ext>
          </c:extLst>
        </c:ser>
        <c:ser>
          <c:idx val="3"/>
          <c:order val="2"/>
          <c:tx>
            <c:strRef>
              <c:f>Sheet1!$AK$2</c:f>
              <c:strCache>
                <c:ptCount val="1"/>
                <c:pt idx="0">
                  <c:v>Sonographer 3</c:v>
                </c:pt>
              </c:strCache>
            </c:strRef>
          </c:tx>
          <c:spPr>
            <a:ln>
              <a:solidFill>
                <a:schemeClr val="accent1"/>
              </a:solidFill>
              <a:prstDash val="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N$3:$AN$25</c:f>
                <c:numCache>
                  <c:formatCode>General</c:formatCode>
                  <c:ptCount val="23"/>
                  <c:pt idx="1">
                    <c:v>15.7</c:v>
                  </c:pt>
                  <c:pt idx="2">
                    <c:v>19.7</c:v>
                  </c:pt>
                  <c:pt idx="3">
                    <c:v>21.3</c:v>
                  </c:pt>
                  <c:pt idx="4">
                    <c:v>31.6</c:v>
                  </c:pt>
                  <c:pt idx="5">
                    <c:v>35.6</c:v>
                  </c:pt>
                  <c:pt idx="6">
                    <c:v>37.5</c:v>
                  </c:pt>
                  <c:pt idx="7">
                    <c:v>57.8</c:v>
                  </c:pt>
                  <c:pt idx="8">
                    <c:v>53.7</c:v>
                  </c:pt>
                  <c:pt idx="9">
                    <c:v>46.6</c:v>
                  </c:pt>
                  <c:pt idx="10">
                    <c:v>69.599999999999994</c:v>
                  </c:pt>
                  <c:pt idx="11">
                    <c:v>102.6</c:v>
                  </c:pt>
                  <c:pt idx="12">
                    <c:v>107.1</c:v>
                  </c:pt>
                  <c:pt idx="13">
                    <c:v>135.69999999999999</c:v>
                  </c:pt>
                  <c:pt idx="14">
                    <c:v>119</c:v>
                  </c:pt>
                  <c:pt idx="15">
                    <c:v>188.7</c:v>
                  </c:pt>
                  <c:pt idx="16">
                    <c:v>189.4</c:v>
                  </c:pt>
                  <c:pt idx="17">
                    <c:v>225.5</c:v>
                  </c:pt>
                  <c:pt idx="18">
                    <c:v>197.5</c:v>
                  </c:pt>
                  <c:pt idx="19">
                    <c:v>203.5</c:v>
                  </c:pt>
                  <c:pt idx="20">
                    <c:v>205.4</c:v>
                  </c:pt>
                  <c:pt idx="21">
                    <c:v>294.3</c:v>
                  </c:pt>
                  <c:pt idx="22">
                    <c:v>243.9</c:v>
                  </c:pt>
                </c:numCache>
              </c:numRef>
            </c:plus>
            <c:minus>
              <c:numRef>
                <c:f>Sheet1!$AN$3:$AN$25</c:f>
                <c:numCache>
                  <c:formatCode>General</c:formatCode>
                  <c:ptCount val="23"/>
                  <c:pt idx="1">
                    <c:v>15.7</c:v>
                  </c:pt>
                  <c:pt idx="2">
                    <c:v>19.7</c:v>
                  </c:pt>
                  <c:pt idx="3">
                    <c:v>21.3</c:v>
                  </c:pt>
                  <c:pt idx="4">
                    <c:v>31.6</c:v>
                  </c:pt>
                  <c:pt idx="5">
                    <c:v>35.6</c:v>
                  </c:pt>
                  <c:pt idx="6">
                    <c:v>37.5</c:v>
                  </c:pt>
                  <c:pt idx="7">
                    <c:v>57.8</c:v>
                  </c:pt>
                  <c:pt idx="8">
                    <c:v>53.7</c:v>
                  </c:pt>
                  <c:pt idx="9">
                    <c:v>46.6</c:v>
                  </c:pt>
                  <c:pt idx="10">
                    <c:v>69.599999999999994</c:v>
                  </c:pt>
                  <c:pt idx="11">
                    <c:v>102.6</c:v>
                  </c:pt>
                  <c:pt idx="12">
                    <c:v>107.1</c:v>
                  </c:pt>
                  <c:pt idx="13">
                    <c:v>135.69999999999999</c:v>
                  </c:pt>
                  <c:pt idx="14">
                    <c:v>119</c:v>
                  </c:pt>
                  <c:pt idx="15">
                    <c:v>188.7</c:v>
                  </c:pt>
                  <c:pt idx="16">
                    <c:v>189.4</c:v>
                  </c:pt>
                  <c:pt idx="17">
                    <c:v>225.5</c:v>
                  </c:pt>
                  <c:pt idx="18">
                    <c:v>197.5</c:v>
                  </c:pt>
                  <c:pt idx="19">
                    <c:v>203.5</c:v>
                  </c:pt>
                  <c:pt idx="20">
                    <c:v>205.4</c:v>
                  </c:pt>
                  <c:pt idx="21">
                    <c:v>294.3</c:v>
                  </c:pt>
                  <c:pt idx="22">
                    <c:v>243.9</c:v>
                  </c:pt>
                </c:numCache>
              </c:numRef>
            </c:minus>
            <c:spPr>
              <a:ln>
                <a:solidFill>
                  <a:schemeClr val="accent1"/>
                </a:solidFill>
              </a:ln>
            </c:spPr>
          </c:errBars>
          <c:cat>
            <c:numRef>
              <c:f>Sheet1!$AG$3:$AG$25</c:f>
              <c:numCache>
                <c:formatCode>General</c:formatCode>
                <c:ptCount val="23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</c:numCache>
            </c:numRef>
          </c:cat>
          <c:val>
            <c:numRef>
              <c:f>Sheet1!$AK$3:$AK$25</c:f>
              <c:numCache>
                <c:formatCode>General</c:formatCode>
                <c:ptCount val="23"/>
                <c:pt idx="1">
                  <c:v>127.1</c:v>
                </c:pt>
                <c:pt idx="2">
                  <c:v>162.69999999999999</c:v>
                </c:pt>
                <c:pt idx="3">
                  <c:v>196.2</c:v>
                </c:pt>
                <c:pt idx="4">
                  <c:v>250.4</c:v>
                </c:pt>
                <c:pt idx="5">
                  <c:v>299.60000000000002</c:v>
                </c:pt>
                <c:pt idx="6">
                  <c:v>352.9</c:v>
                </c:pt>
                <c:pt idx="7">
                  <c:v>424</c:v>
                </c:pt>
                <c:pt idx="8">
                  <c:v>507.8</c:v>
                </c:pt>
                <c:pt idx="9">
                  <c:v>586.9</c:v>
                </c:pt>
                <c:pt idx="10">
                  <c:v>696.4</c:v>
                </c:pt>
                <c:pt idx="11">
                  <c:v>835.2</c:v>
                </c:pt>
                <c:pt idx="12">
                  <c:v>882.5</c:v>
                </c:pt>
                <c:pt idx="13">
                  <c:v>1120.8</c:v>
                </c:pt>
                <c:pt idx="14">
                  <c:v>1119.8</c:v>
                </c:pt>
                <c:pt idx="15">
                  <c:v>1329.8</c:v>
                </c:pt>
                <c:pt idx="16">
                  <c:v>1480.7</c:v>
                </c:pt>
                <c:pt idx="17">
                  <c:v>1624.6</c:v>
                </c:pt>
                <c:pt idx="18">
                  <c:v>1827.2</c:v>
                </c:pt>
                <c:pt idx="19">
                  <c:v>1922.2</c:v>
                </c:pt>
                <c:pt idx="20">
                  <c:v>2209.3000000000002</c:v>
                </c:pt>
                <c:pt idx="21">
                  <c:v>2336.8000000000002</c:v>
                </c:pt>
                <c:pt idx="22">
                  <c:v>2621.3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5BB-4C17-9D0C-B6AC843DA5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6489600"/>
        <c:axId val="116549504"/>
      </c:lineChart>
      <c:catAx>
        <c:axId val="116489600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Gestaional age (weeks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16549504"/>
        <c:crosses val="autoZero"/>
        <c:auto val="1"/>
        <c:lblAlgn val="ctr"/>
        <c:lblOffset val="100"/>
        <c:noMultiLvlLbl val="0"/>
      </c:catAx>
      <c:valAx>
        <c:axId val="116549504"/>
        <c:scaling>
          <c:orientation val="minMax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stimate fetal weight(g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7.6980380187227065E-3"/>
              <c:y val="0.286774152826220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648960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0229314667937492"/>
          <c:y val="2.1024964247903642E-2"/>
          <c:w val="0.85816619554873685"/>
          <c:h val="5.2852952448539194E-2"/>
        </c:manualLayout>
      </c:layout>
      <c:overlay val="0"/>
      <c:txPr>
        <a:bodyPr/>
        <a:lstStyle/>
        <a:p>
          <a:pPr>
            <a:defRPr b="1"/>
          </a:pPr>
          <a:endParaRPr lang="zh-CN"/>
        </a:p>
      </c:txPr>
    </c:legend>
    <c:plotVisOnly val="1"/>
    <c:dispBlanksAs val="gap"/>
    <c:showDLblsOverMax val="0"/>
  </c:chart>
  <c:spPr>
    <a:ln>
      <a:solidFill>
        <a:schemeClr val="accent1"/>
      </a:solidFill>
    </a:ln>
  </c:spPr>
  <c:txPr>
    <a:bodyPr/>
    <a:lstStyle/>
    <a:p>
      <a:pPr>
        <a:defRPr sz="1400"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E59430-0704-4A8E-AF15-1A3C4CDC16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468EA46-B76E-4386-B274-DFAFC0D63F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C8C885-1164-47B8-A1B6-CF3F61DE1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9CFE32-205C-4B8F-917D-BB6A21B35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80565E-4E19-4D44-9CA3-F21A342DF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118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75B577-3FF5-4580-A9FB-A653212851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C85A78-8183-4B54-9161-FA809FCED3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D7F258-85BD-4FB7-8AF8-EA0330674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3A2A20-EAC6-472F-BED8-E3E1B8A6F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0AD8A8-EC19-438B-A595-E9468D21B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46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6C745CA-3275-47DA-99D0-7DAECE3F74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2C551E-CEC9-4F44-822D-6BE9E6BEA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1222F1-7286-474D-AF64-870B99727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E0D711-E424-4AF6-89EA-0CDDC9A05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1E7D4D-9E55-4EFD-9428-CCABC520C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597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0602C5-8DEF-4D65-A82A-15F29FDAF2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D243B7-49CA-42EA-827D-21A510B24A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56E142-18B4-4933-A64E-B1B103113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556C91-14AD-4BFA-B8D6-AD6B76ABA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1EABA0-1133-49B1-8CCC-306956C57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86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E4D869-3145-4994-BEDB-8B20736A9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7CD45F0-3377-4230-8400-5D4571079D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2774DC-CCFE-42C4-A902-7843E07F1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FC5210-0629-4A0C-96C2-51092A594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45542C-ED5A-4B6F-B629-E79822026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545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93703B-FA68-4D69-AEC6-7905A4414A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B411E8-AC00-4105-9FB6-FBE0C41C16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F6ADD2-471A-45EA-9D60-21248805A1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5128ECF-F895-49A4-8578-51B204DD1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06D1CA-ABF5-400A-9F49-C37286179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0E4CB8-BB10-4140-9305-66E12554D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301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302C84-94D3-4766-9491-00912588E4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C0F7B1-B259-48A7-B990-A280E783C6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5B903F1-F7D1-4621-83FF-F0CCC5C5F9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C0A2BFF-DDA5-4DF1-942C-A518D64A4B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B30B399-675A-43E0-B140-4F081F3F80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63AAA91-5165-476B-96BE-DA6A02751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7EBB0BF-11DC-4BC4-8149-34B4A8CE9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D156E10-A898-4752-A3D4-B2206F0A7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6037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12F328-B546-4504-A2F1-0C697149B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50232CF-B6A5-4627-B676-215C7ADE2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8AD5AE5-8147-47E6-8B4B-273E1E926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60E1F4-E423-4D28-B6FA-F039E94EF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2159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3DDA829-74F3-4B10-B593-CD1569320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6D3B0AD-3685-446C-95B6-2C1F95172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8DAEC7-5DAF-45E5-BB08-FD5944AC0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047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A622A9-7DCD-4789-A918-8A2D6B202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297BCD-E41D-4F1A-ABEA-E3E189724B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D498D9-FAD9-4FCE-8D6D-550357BF4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43F3CD-D81D-4F9C-B2E9-C4FF1E16C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ED1B2E-9DF9-4ED8-B871-03AC4BC45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72AF2D-3294-4A26-8A18-ABCE102FB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229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27928C-BD5A-4D30-8101-9111C1368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E7A386B-4B32-4472-90CB-E9BCE5D15B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8AF804E-E2D1-4D7A-ACC0-4EC5E6C6F7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B7A2C1-29F3-4565-BDCA-6074AA2112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035455-DF0A-4503-A9A5-D81F463BB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005AEE9-58CE-40F4-8C77-FEA951C3B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01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FA74092-F36C-414B-A9F6-A500626F7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980E0F-6B41-4A28-A019-11584BC70B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1A67C1-C4F8-497A-93AA-4C60A49D22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A694B-F153-4A51-A955-BE9CA4ED9D4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3A7F15-3430-4650-813A-4FFBF56A59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B660B4-EE77-4A71-8713-C0E3C03D53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CAB8B-AF71-48D0-9DB1-B23F731ED1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6991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0000000-0008-0000-03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1974439"/>
              </p:ext>
            </p:extLst>
          </p:nvPr>
        </p:nvGraphicFramePr>
        <p:xfrm>
          <a:off x="767080" y="152400"/>
          <a:ext cx="10657840" cy="6167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5BA5258C-BEE2-442F-ADAB-660D4B93D6B8}"/>
              </a:ext>
            </a:extLst>
          </p:cNvPr>
          <p:cNvSpPr txBox="1"/>
          <p:nvPr/>
        </p:nvSpPr>
        <p:spPr>
          <a:xfrm>
            <a:off x="767080" y="6417995"/>
            <a:ext cx="108458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Supplementary Figure S2</a:t>
            </a:r>
            <a:r>
              <a:rPr lang="en-US" altLang="zh-CN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. Mean estimate fetal weight by gestational age for three sonographer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42226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5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lia</dc:creator>
  <cp:lastModifiedBy>julia</cp:lastModifiedBy>
  <cp:revision>2</cp:revision>
  <dcterms:created xsi:type="dcterms:W3CDTF">2021-06-19T13:29:41Z</dcterms:created>
  <dcterms:modified xsi:type="dcterms:W3CDTF">2021-06-19T13:38:30Z</dcterms:modified>
</cp:coreProperties>
</file>